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B5EC70-143A-486F-AC3C-5AE14254442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51A50A-45BC-4E74-84CD-5931C40DB86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B3A2E0-3AA8-48AE-8FEA-E9536D023A6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B05FA6-13E7-4106-9F20-8B7EAF5D630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926141-2FBB-46DE-98C2-A65586AAF1A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E88CEC-D074-45C1-A95B-D15D7BE4C11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A480A1-A29F-47F1-AAA6-060B8902AFF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D80792-15FC-409C-9C58-A4E0F0AEFD7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817E16-94C1-412B-A262-5F6ACDA4E5E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0A66C1-7EDD-419F-AC3C-936143C1CD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16E892-FB09-4137-B07E-B93D172631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F1B1D5-97E6-4F49-B906-AE6F3E5F5A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D79EB95-B764-41E9-AE9E-CC1858473BE8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7"/>
          <p:cNvSpPr/>
          <p:nvPr/>
        </p:nvSpPr>
        <p:spPr>
          <a:xfrm>
            <a:off x="-142920" y="2265480"/>
            <a:ext cx="7143840" cy="36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42" name="直接箭头连接符 10"/>
          <p:cNvCxnSpPr/>
          <p:nvPr/>
        </p:nvCxnSpPr>
        <p:spPr>
          <a:xfrm>
            <a:off x="178920" y="2327400"/>
            <a:ext cx="7201800" cy="2160"/>
          </a:xfrm>
          <a:prstGeom prst="straightConnector1">
            <a:avLst/>
          </a:prstGeom>
          <a:ln w="4752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43" name="TextBox 12"/>
          <p:cNvSpPr/>
          <p:nvPr/>
        </p:nvSpPr>
        <p:spPr>
          <a:xfrm>
            <a:off x="7000920" y="4924440"/>
            <a:ext cx="785880" cy="36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44" name="直接箭头连接符 13"/>
          <p:cNvCxnSpPr/>
          <p:nvPr/>
        </p:nvCxnSpPr>
        <p:spPr>
          <a:xfrm>
            <a:off x="142920" y="5423040"/>
            <a:ext cx="8928720" cy="2160"/>
          </a:xfrm>
          <a:prstGeom prst="straightConnector1">
            <a:avLst/>
          </a:prstGeom>
          <a:ln w="4752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45" name="TextBox 14"/>
          <p:cNvSpPr/>
          <p:nvPr/>
        </p:nvSpPr>
        <p:spPr>
          <a:xfrm>
            <a:off x="108000" y="1386000"/>
            <a:ext cx="857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Day 0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15"/>
          <p:cNvSpPr/>
          <p:nvPr/>
        </p:nvSpPr>
        <p:spPr>
          <a:xfrm>
            <a:off x="2124000" y="1386000"/>
            <a:ext cx="857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Day 28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16"/>
          <p:cNvSpPr/>
          <p:nvPr/>
        </p:nvSpPr>
        <p:spPr>
          <a:xfrm>
            <a:off x="4689360" y="1386000"/>
            <a:ext cx="857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Day 56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17"/>
          <p:cNvSpPr/>
          <p:nvPr/>
        </p:nvSpPr>
        <p:spPr>
          <a:xfrm>
            <a:off x="71280" y="4473720"/>
            <a:ext cx="857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Day 0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8"/>
          <p:cNvSpPr/>
          <p:nvPr/>
        </p:nvSpPr>
        <p:spPr>
          <a:xfrm>
            <a:off x="2143080" y="4473720"/>
            <a:ext cx="857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Day 28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19"/>
          <p:cNvSpPr/>
          <p:nvPr/>
        </p:nvSpPr>
        <p:spPr>
          <a:xfrm>
            <a:off x="6815160" y="4473720"/>
            <a:ext cx="857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Day 56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20"/>
          <p:cNvSpPr/>
          <p:nvPr/>
        </p:nvSpPr>
        <p:spPr>
          <a:xfrm>
            <a:off x="4572000" y="4473720"/>
            <a:ext cx="857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Day 48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22"/>
          <p:cNvSpPr/>
          <p:nvPr/>
        </p:nvSpPr>
        <p:spPr>
          <a:xfrm>
            <a:off x="0" y="884160"/>
            <a:ext cx="785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23"/>
          <p:cNvSpPr/>
          <p:nvPr/>
        </p:nvSpPr>
        <p:spPr>
          <a:xfrm>
            <a:off x="0" y="3908520"/>
            <a:ext cx="785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21"/>
          <p:cNvSpPr/>
          <p:nvPr/>
        </p:nvSpPr>
        <p:spPr>
          <a:xfrm>
            <a:off x="-104760" y="1798560"/>
            <a:ext cx="2214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ell Transplantation at Adrenal Sit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24"/>
          <p:cNvSpPr/>
          <p:nvPr/>
        </p:nvSpPr>
        <p:spPr>
          <a:xfrm>
            <a:off x="71280" y="2386080"/>
            <a:ext cx="18576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K-N-LP Group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(N=4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25"/>
          <p:cNvSpPr/>
          <p:nvPr/>
        </p:nvSpPr>
        <p:spPr>
          <a:xfrm>
            <a:off x="2050920" y="1954080"/>
            <a:ext cx="2376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valuation of Tumor Growt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26"/>
          <p:cNvSpPr/>
          <p:nvPr/>
        </p:nvSpPr>
        <p:spPr>
          <a:xfrm>
            <a:off x="1928880" y="2739960"/>
            <a:ext cx="2643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Xenogen IVIS 100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In Vivo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Imaging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27"/>
          <p:cNvSpPr/>
          <p:nvPr/>
        </p:nvSpPr>
        <p:spPr>
          <a:xfrm>
            <a:off x="4594320" y="1954080"/>
            <a:ext cx="242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valuation of Tumor Growt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28"/>
          <p:cNvSpPr/>
          <p:nvPr/>
        </p:nvSpPr>
        <p:spPr>
          <a:xfrm>
            <a:off x="4665600" y="2739960"/>
            <a:ext cx="264312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Xenogen IVIS 100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In Vivo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Imaging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&amp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umor Volume Evalua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29"/>
          <p:cNvSpPr/>
          <p:nvPr/>
        </p:nvSpPr>
        <p:spPr>
          <a:xfrm>
            <a:off x="-23760" y="2957400"/>
            <a:ext cx="21430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K-N-LP+hMSCs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o-transplantation Group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(N=4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30"/>
          <p:cNvSpPr/>
          <p:nvPr/>
        </p:nvSpPr>
        <p:spPr>
          <a:xfrm>
            <a:off x="0" y="4751280"/>
            <a:ext cx="22590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K-N-LP Cell Transplantation at Adrenal Site (N=8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32"/>
          <p:cNvSpPr/>
          <p:nvPr/>
        </p:nvSpPr>
        <p:spPr>
          <a:xfrm>
            <a:off x="2143080" y="4937040"/>
            <a:ext cx="2284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valuation of Tumor Growt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33"/>
          <p:cNvSpPr/>
          <p:nvPr/>
        </p:nvSpPr>
        <p:spPr>
          <a:xfrm>
            <a:off x="1908000" y="5576760"/>
            <a:ext cx="2643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Xenogen IVIS 100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In Vivo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Imaging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34"/>
          <p:cNvSpPr/>
          <p:nvPr/>
        </p:nvSpPr>
        <p:spPr>
          <a:xfrm>
            <a:off x="4572000" y="4937040"/>
            <a:ext cx="2376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ystemic Infusion of hMSC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35"/>
          <p:cNvSpPr/>
          <p:nvPr/>
        </p:nvSpPr>
        <p:spPr>
          <a:xfrm>
            <a:off x="6815160" y="4937040"/>
            <a:ext cx="2500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valuation of hMSCs Homing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36"/>
          <p:cNvSpPr/>
          <p:nvPr/>
        </p:nvSpPr>
        <p:spPr>
          <a:xfrm>
            <a:off x="4572000" y="5576760"/>
            <a:ext cx="2500200" cy="495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1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hMSCs Group (N=4)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1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hMSCs + AMD3100 Group (N=4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37"/>
          <p:cNvSpPr/>
          <p:nvPr/>
        </p:nvSpPr>
        <p:spPr>
          <a:xfrm>
            <a:off x="6819840" y="5576760"/>
            <a:ext cx="2610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RI Maestro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TM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In Vivo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Imaging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29"/>
          <p:cNvSpPr/>
          <p:nvPr/>
        </p:nvSpPr>
        <p:spPr>
          <a:xfrm>
            <a:off x="0" y="357120"/>
            <a:ext cx="9715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Experimental Desig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1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03-06T06:05:12Z</dcterms:created>
  <dc:creator>lenovo</dc:creator>
  <dc:description/>
  <dc:language>en-US</dc:language>
  <cp:lastModifiedBy>lenovo</cp:lastModifiedBy>
  <dcterms:modified xsi:type="dcterms:W3CDTF">2021-03-17T13:03:57Z</dcterms:modified>
  <cp:revision>131</cp:revision>
  <dc:subject/>
  <dc:title>幻灯片 1</dc:title>
</cp:coreProperties>
</file>